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64" autoAdjust="0"/>
  </p:normalViewPr>
  <p:slideViewPr>
    <p:cSldViewPr snapToGrid="0">
      <p:cViewPr varScale="1">
        <p:scale>
          <a:sx n="80" d="100"/>
          <a:sy n="80" d="100"/>
        </p:scale>
        <p:origin x="3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 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FA022E-2159-4251-AD84-7D5E29DC0DBF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4" name="Slayt Resmi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r-TR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6" name="Alt 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E66514-87DE-43CC-9A73-A9017E4E74D5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827033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E66514-87DE-43CC-9A73-A9017E4E74D5}" type="slidenum">
              <a:rPr lang="tr-TR" smtClean="0"/>
              <a:t>1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4277619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57CB620E-6678-3F52-C129-DE2EF36AAE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FE2FA054-C185-D3E2-5E20-816DB62339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D248832-218F-40B8-1CA6-B08230EA8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D697F75-BFD7-1086-08BC-F2A6A6F2F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2B214CCC-879D-8954-EBD9-953B72896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754945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150231CB-67F8-36B9-4166-BE6C0EAAF6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7F160597-F9CC-920E-584E-A8DD5484D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608494D7-E461-B494-B77F-7C701CC44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CDAABA28-5060-1D0B-E560-E33A3C770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0FC443A-1CE9-4A16-E252-B150896AE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301338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BC5A8A77-25D9-A4DC-B547-9DC3AD29C1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9DB650CA-8A52-609E-D905-2C7D2EF88F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3D405EA-9980-CA64-4A6A-FF8D57744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39107C1B-9890-D122-C8EB-EE7F4E9F5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53A2C781-30E3-B64B-B979-686CB0E4D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135548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93BD4133-A3CF-ADC4-C407-0C1C105291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11FCEC40-CC95-D6BF-DD07-A5E6C1250D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50CD3E0F-B315-752B-FB64-B986F4339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2737BD6B-0D87-A896-094E-20F7DE405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63BBC32E-D7B7-012E-A575-A09A2224E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579569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D5DFB85-1925-7ABE-2EB8-E27DDA3FF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C1182B48-AC8F-225F-A812-64A324E8B7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E1739A3-8FEB-9F67-4901-96B8FB51B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C03A1005-0214-5C0C-78A2-5745956BC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4AC760E-938F-25BC-ED2D-63F277D91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423820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3206ACCE-822F-BED5-3072-B49CEBEC8A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24801C01-1E87-9127-F696-A1315E6A05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6C725BD3-D3AC-F0CE-599B-E154284FC5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D63A4D91-3586-E103-97B0-1AE730735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AEE674AD-31A9-D27A-635A-068916720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0C5988DF-884C-8AC5-3ED4-EBF421837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164388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903FCDFA-9F86-B237-87F4-A766C6F35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3177D130-E0A0-1D29-46A2-C0A2AC874D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0881D63A-8F29-BFF0-9FE7-C2C4DD650C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08318494-D9D8-4164-993E-77009CC650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3F4B1ECC-3DC1-F62A-EB1F-9DD40180EF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F1D1D972-F58A-AB8E-DA53-33145474B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37B9E9FE-38C9-2CB1-8247-593D44265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8ACA7F69-F6C7-23A8-FAB0-1FEA3733F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046682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87550386-2F3F-7273-DF0D-EA42B23BEC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69365BD6-AE98-098D-D805-9460C75D0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63394744-51BE-9A55-327A-68FC3B5F7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E87BC4F8-3606-CF7F-C056-AD1AD6D55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593061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460BC869-7C02-5107-C305-AC7B48D12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49F3DF1D-C10B-72A7-F795-4D7A316F7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BC996DFC-0A77-D398-0DA5-00C46BE44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79162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C6450D5-0B52-246F-E804-04FA1E96E1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E1E01F9B-C001-80FA-A48F-67C616E7AF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88AF11E6-B9E0-0ECD-0125-D73B245073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CF05C790-BA07-881A-0459-FE7A9B453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070F247B-84E2-8E22-136A-3AF094470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8312F04C-FC05-E551-E447-1A8BC77F6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815506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F0BAA735-0EEB-2914-36B6-48B8013EB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D9F625EF-4500-FF0E-DFD8-5931863493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CD290A82-2851-8E84-91CF-1A88EFC9F4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9DF079FC-5FB6-907D-B7EF-0EF87FE75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A65F4343-5DB2-27A8-F2DF-51B974931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608BF1BC-5BF2-62F3-F2B7-AB81D2FC1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414435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DE31EAD6-0CEA-964C-4231-4B592E91D0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75EE9009-2742-D756-6348-CBFEFEE53F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95CBA410-FCAA-D2AF-6351-FE73D57139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5325E-115C-4418-A2AC-F06C8DADB60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E6024CE5-C85E-C120-36B6-B67B6E8FB0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A23634D-4C14-A5C0-63B9-080D64D919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8C33-F428-4790-9672-DC2C0E13E87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996095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 1">
            <a:extLst>
              <a:ext uri="{FF2B5EF4-FFF2-40B4-BE49-F238E27FC236}">
                <a16:creationId xmlns:a16="http://schemas.microsoft.com/office/drawing/2014/main" id="{7F6E7F67-80D6-45E2-A78D-F71A3BDDE5ED}"/>
              </a:ext>
            </a:extLst>
          </p:cNvPr>
          <p:cNvGrpSpPr/>
          <p:nvPr/>
        </p:nvGrpSpPr>
        <p:grpSpPr>
          <a:xfrm>
            <a:off x="187188" y="312955"/>
            <a:ext cx="11817624" cy="6232089"/>
            <a:chOff x="184945" y="107141"/>
            <a:chExt cx="11817624" cy="6232089"/>
          </a:xfrm>
        </p:grpSpPr>
        <p:grpSp>
          <p:nvGrpSpPr>
            <p:cNvPr id="30" name="Grup 29">
              <a:extLst>
                <a:ext uri="{FF2B5EF4-FFF2-40B4-BE49-F238E27FC236}">
                  <a16:creationId xmlns:a16="http://schemas.microsoft.com/office/drawing/2014/main" id="{A6EE0FA4-D1E6-2644-1830-8750710AC338}"/>
                </a:ext>
              </a:extLst>
            </p:cNvPr>
            <p:cNvGrpSpPr/>
            <p:nvPr/>
          </p:nvGrpSpPr>
          <p:grpSpPr>
            <a:xfrm>
              <a:off x="1442589" y="518768"/>
              <a:ext cx="4056649" cy="5820462"/>
              <a:chOff x="2625119" y="319082"/>
              <a:chExt cx="2897473" cy="4785696"/>
            </a:xfrm>
          </p:grpSpPr>
          <p:pic>
            <p:nvPicPr>
              <p:cNvPr id="5" name="Resim 4">
                <a:extLst>
                  <a:ext uri="{FF2B5EF4-FFF2-40B4-BE49-F238E27FC236}">
                    <a16:creationId xmlns:a16="http://schemas.microsoft.com/office/drawing/2014/main" id="{511D6F53-07E9-77A8-B1CD-05612B40DC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89079" y="319082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7" name="Resim 6">
                <a:extLst>
                  <a:ext uri="{FF2B5EF4-FFF2-40B4-BE49-F238E27FC236}">
                    <a16:creationId xmlns:a16="http://schemas.microsoft.com/office/drawing/2014/main" id="{6F146E8F-E3E0-CA0A-23A7-53731A81F0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25119" y="319082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9" name="Resim 8">
                <a:extLst>
                  <a:ext uri="{FF2B5EF4-FFF2-40B4-BE49-F238E27FC236}">
                    <a16:creationId xmlns:a16="http://schemas.microsoft.com/office/drawing/2014/main" id="{FC7FF175-71EC-1024-22E3-B95AC12054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25121" y="113523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3" name="Resim 12">
                <a:extLst>
                  <a:ext uri="{FF2B5EF4-FFF2-40B4-BE49-F238E27FC236}">
                    <a16:creationId xmlns:a16="http://schemas.microsoft.com/office/drawing/2014/main" id="{35634907-17AB-206C-3A1A-C5896D1D02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89079" y="113523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5" name="Resim 14">
                <a:extLst>
                  <a:ext uri="{FF2B5EF4-FFF2-40B4-BE49-F238E27FC236}">
                    <a16:creationId xmlns:a16="http://schemas.microsoft.com/office/drawing/2014/main" id="{D2EDC82B-23D2-B543-5543-A18D366397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25121" y="1934249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7" name="Resim 16">
                <a:extLst>
                  <a:ext uri="{FF2B5EF4-FFF2-40B4-BE49-F238E27FC236}">
                    <a16:creationId xmlns:a16="http://schemas.microsoft.com/office/drawing/2014/main" id="{4A54AD70-18CB-9542-ECB7-92FA942DF1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89079" y="193424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9" name="Resim 18">
                <a:extLst>
                  <a:ext uri="{FF2B5EF4-FFF2-40B4-BE49-F238E27FC236}">
                    <a16:creationId xmlns:a16="http://schemas.microsoft.com/office/drawing/2014/main" id="{E5CCDD2B-7FC9-44B6-96ED-2AB3FF57A8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25121" y="272460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1" name="Resim 20">
                <a:extLst>
                  <a:ext uri="{FF2B5EF4-FFF2-40B4-BE49-F238E27FC236}">
                    <a16:creationId xmlns:a16="http://schemas.microsoft.com/office/drawing/2014/main" id="{4B1F2D6B-652E-6F5A-B6A5-E55809B7AB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89078" y="2724607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3" name="Resim 22">
                <a:extLst>
                  <a:ext uri="{FF2B5EF4-FFF2-40B4-BE49-F238E27FC236}">
                    <a16:creationId xmlns:a16="http://schemas.microsoft.com/office/drawing/2014/main" id="{E772692C-0F34-1257-3EE4-3BBD462B16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25120" y="3528856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5" name="Resim 24">
                <a:extLst>
                  <a:ext uri="{FF2B5EF4-FFF2-40B4-BE49-F238E27FC236}">
                    <a16:creationId xmlns:a16="http://schemas.microsoft.com/office/drawing/2014/main" id="{DE1A1417-DB0B-5389-D344-5293E9406A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89078" y="3529956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7" name="Resim 26">
                <a:extLst>
                  <a:ext uri="{FF2B5EF4-FFF2-40B4-BE49-F238E27FC236}">
                    <a16:creationId xmlns:a16="http://schemas.microsoft.com/office/drawing/2014/main" id="{EFF068BF-ABA8-F119-8A2D-22B731A432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25119" y="4334205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9" name="Resim 28">
                <a:extLst>
                  <a:ext uri="{FF2B5EF4-FFF2-40B4-BE49-F238E27FC236}">
                    <a16:creationId xmlns:a16="http://schemas.microsoft.com/office/drawing/2014/main" id="{7BF64E78-8692-62CD-19D7-2EE2C16FCE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89078" y="4334204"/>
                <a:ext cx="1433513" cy="770573"/>
              </a:xfrm>
              <a:prstGeom prst="rect">
                <a:avLst/>
              </a:prstGeom>
            </p:spPr>
          </p:pic>
        </p:grpSp>
        <p:grpSp>
          <p:nvGrpSpPr>
            <p:cNvPr id="55" name="Grup 54">
              <a:extLst>
                <a:ext uri="{FF2B5EF4-FFF2-40B4-BE49-F238E27FC236}">
                  <a16:creationId xmlns:a16="http://schemas.microsoft.com/office/drawing/2014/main" id="{1E4679F1-C6EE-56FE-8BA9-86DB87BB5A80}"/>
                </a:ext>
              </a:extLst>
            </p:cNvPr>
            <p:cNvGrpSpPr/>
            <p:nvPr/>
          </p:nvGrpSpPr>
          <p:grpSpPr>
            <a:xfrm>
              <a:off x="6096000" y="518769"/>
              <a:ext cx="3860800" cy="5820461"/>
              <a:chOff x="6669406" y="319082"/>
              <a:chExt cx="2897010" cy="4771181"/>
            </a:xfrm>
          </p:grpSpPr>
          <p:pic>
            <p:nvPicPr>
              <p:cNvPr id="32" name="Resim 31">
                <a:extLst>
                  <a:ext uri="{FF2B5EF4-FFF2-40B4-BE49-F238E27FC236}">
                    <a16:creationId xmlns:a16="http://schemas.microsoft.com/office/drawing/2014/main" id="{C890C9C0-5F0B-24CA-0AB3-5C1DF4B6A7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9410" y="319082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34" name="Resim 33">
                <a:extLst>
                  <a:ext uri="{FF2B5EF4-FFF2-40B4-BE49-F238E27FC236}">
                    <a16:creationId xmlns:a16="http://schemas.microsoft.com/office/drawing/2014/main" id="{7CB26E78-5135-20EC-8105-520F5DF54B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32903" y="319082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36" name="Resim 35">
                <a:extLst>
                  <a:ext uri="{FF2B5EF4-FFF2-40B4-BE49-F238E27FC236}">
                    <a16:creationId xmlns:a16="http://schemas.microsoft.com/office/drawing/2014/main" id="{E7F57188-B80C-4F50-8212-18D97FAD1A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9409" y="1135237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38" name="Resim 37">
                <a:extLst>
                  <a:ext uri="{FF2B5EF4-FFF2-40B4-BE49-F238E27FC236}">
                    <a16:creationId xmlns:a16="http://schemas.microsoft.com/office/drawing/2014/main" id="{D9F7E604-D827-473E-9268-67624E8033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32903" y="1135237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0" name="Resim 39">
                <a:extLst>
                  <a:ext uri="{FF2B5EF4-FFF2-40B4-BE49-F238E27FC236}">
                    <a16:creationId xmlns:a16="http://schemas.microsoft.com/office/drawing/2014/main" id="{34C18E8E-E0DA-F0C5-2C8B-3ECAE768F1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9408" y="193424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2" name="Resim 41">
                <a:extLst>
                  <a:ext uri="{FF2B5EF4-FFF2-40B4-BE49-F238E27FC236}">
                    <a16:creationId xmlns:a16="http://schemas.microsoft.com/office/drawing/2014/main" id="{8EE39469-645E-0961-40E9-2F3B48D0E36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32903" y="193424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4" name="Resim 43">
                <a:extLst>
                  <a:ext uri="{FF2B5EF4-FFF2-40B4-BE49-F238E27FC236}">
                    <a16:creationId xmlns:a16="http://schemas.microsoft.com/office/drawing/2014/main" id="{F9405E99-45A5-2368-EA19-6A5FDFE2D8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9407" y="273325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6" name="Resim 45">
                <a:extLst>
                  <a:ext uri="{FF2B5EF4-FFF2-40B4-BE49-F238E27FC236}">
                    <a16:creationId xmlns:a16="http://schemas.microsoft.com/office/drawing/2014/main" id="{5A25A92A-506A-AA00-C909-774706CF2A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32903" y="273325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8" name="Resim 47">
                <a:extLst>
                  <a:ext uri="{FF2B5EF4-FFF2-40B4-BE49-F238E27FC236}">
                    <a16:creationId xmlns:a16="http://schemas.microsoft.com/office/drawing/2014/main" id="{2AE66F73-C497-CBD3-EBBC-78D0DB45E0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9406" y="3528855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0" name="Resim 49">
                <a:extLst>
                  <a:ext uri="{FF2B5EF4-FFF2-40B4-BE49-F238E27FC236}">
                    <a16:creationId xmlns:a16="http://schemas.microsoft.com/office/drawing/2014/main" id="{677D48A3-0AE9-28AB-0DD2-73298CE808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32903" y="3528855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2" name="Resim 51">
                <a:extLst>
                  <a:ext uri="{FF2B5EF4-FFF2-40B4-BE49-F238E27FC236}">
                    <a16:creationId xmlns:a16="http://schemas.microsoft.com/office/drawing/2014/main" id="{FD56ACD9-97F3-EF4D-4046-A21595DFD1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9406" y="4319690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4" name="Resim 53">
                <a:extLst>
                  <a:ext uri="{FF2B5EF4-FFF2-40B4-BE49-F238E27FC236}">
                    <a16:creationId xmlns:a16="http://schemas.microsoft.com/office/drawing/2014/main" id="{70E608BC-6630-4283-51DC-AAD58E45FA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32902" y="4319690"/>
                <a:ext cx="1433513" cy="770573"/>
              </a:xfrm>
              <a:prstGeom prst="rect">
                <a:avLst/>
              </a:prstGeom>
            </p:spPr>
          </p:pic>
        </p:grpSp>
        <p:sp>
          <p:nvSpPr>
            <p:cNvPr id="56" name="Metin kutusu 55">
              <a:extLst>
                <a:ext uri="{FF2B5EF4-FFF2-40B4-BE49-F238E27FC236}">
                  <a16:creationId xmlns:a16="http://schemas.microsoft.com/office/drawing/2014/main" id="{46AB81D6-FDD2-3DCA-628A-59702A952C25}"/>
                </a:ext>
              </a:extLst>
            </p:cNvPr>
            <p:cNvSpPr txBox="1"/>
            <p:nvPr/>
          </p:nvSpPr>
          <p:spPr>
            <a:xfrm>
              <a:off x="1724560" y="107141"/>
              <a:ext cx="34927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rizontal ( Maximum – Minimum</a:t>
              </a:r>
              <a:r>
                <a:rPr lang="tr-TR" dirty="0"/>
                <a:t>)</a:t>
              </a:r>
            </a:p>
          </p:txBody>
        </p:sp>
        <p:sp>
          <p:nvSpPr>
            <p:cNvPr id="57" name="Metin kutusu 56">
              <a:extLst>
                <a:ext uri="{FF2B5EF4-FFF2-40B4-BE49-F238E27FC236}">
                  <a16:creationId xmlns:a16="http://schemas.microsoft.com/office/drawing/2014/main" id="{845B1BD6-C0AB-722C-3919-B626256E8B9C}"/>
                </a:ext>
              </a:extLst>
            </p:cNvPr>
            <p:cNvSpPr txBox="1"/>
            <p:nvPr/>
          </p:nvSpPr>
          <p:spPr>
            <a:xfrm>
              <a:off x="6364997" y="107141"/>
              <a:ext cx="32828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lique ( Maximum – Minimum)</a:t>
              </a:r>
            </a:p>
          </p:txBody>
        </p:sp>
        <p:sp>
          <p:nvSpPr>
            <p:cNvPr id="58" name="Metin kutusu 57">
              <a:extLst>
                <a:ext uri="{FF2B5EF4-FFF2-40B4-BE49-F238E27FC236}">
                  <a16:creationId xmlns:a16="http://schemas.microsoft.com/office/drawing/2014/main" id="{9B3BA78A-DCAE-1AF4-04AF-0F47F53B594A}"/>
                </a:ext>
              </a:extLst>
            </p:cNvPr>
            <p:cNvSpPr txBox="1"/>
            <p:nvPr/>
          </p:nvSpPr>
          <p:spPr>
            <a:xfrm>
              <a:off x="184945" y="1297887"/>
              <a:ext cx="141550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2</a:t>
              </a:r>
            </a:p>
          </p:txBody>
        </p:sp>
        <p:sp>
          <p:nvSpPr>
            <p:cNvPr id="59" name="Metin kutusu 58">
              <a:extLst>
                <a:ext uri="{FF2B5EF4-FFF2-40B4-BE49-F238E27FC236}">
                  <a16:creationId xmlns:a16="http://schemas.microsoft.com/office/drawing/2014/main" id="{0D995EA1-B1C1-1146-59B8-DABA4914D153}"/>
                </a:ext>
              </a:extLst>
            </p:cNvPr>
            <p:cNvSpPr txBox="1"/>
            <p:nvPr/>
          </p:nvSpPr>
          <p:spPr>
            <a:xfrm>
              <a:off x="189431" y="445695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1</a:t>
              </a:r>
            </a:p>
          </p:txBody>
        </p:sp>
        <p:sp>
          <p:nvSpPr>
            <p:cNvPr id="60" name="Metin kutusu 59">
              <a:extLst>
                <a:ext uri="{FF2B5EF4-FFF2-40B4-BE49-F238E27FC236}">
                  <a16:creationId xmlns:a16="http://schemas.microsoft.com/office/drawing/2014/main" id="{69A8674C-9908-5221-66BB-0BCD908EC4FC}"/>
                </a:ext>
              </a:extLst>
            </p:cNvPr>
            <p:cNvSpPr txBox="1"/>
            <p:nvPr/>
          </p:nvSpPr>
          <p:spPr>
            <a:xfrm>
              <a:off x="189431" y="2150079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3</a:t>
              </a:r>
            </a:p>
          </p:txBody>
        </p:sp>
        <p:sp>
          <p:nvSpPr>
            <p:cNvPr id="61" name="Metin kutusu 60">
              <a:extLst>
                <a:ext uri="{FF2B5EF4-FFF2-40B4-BE49-F238E27FC236}">
                  <a16:creationId xmlns:a16="http://schemas.microsoft.com/office/drawing/2014/main" id="{A442C8E2-392A-DA89-6C24-23D9221F3826}"/>
                </a:ext>
              </a:extLst>
            </p:cNvPr>
            <p:cNvSpPr txBox="1"/>
            <p:nvPr/>
          </p:nvSpPr>
          <p:spPr>
            <a:xfrm>
              <a:off x="189431" y="3002271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4</a:t>
              </a:r>
            </a:p>
          </p:txBody>
        </p:sp>
        <p:sp>
          <p:nvSpPr>
            <p:cNvPr id="62" name="Metin kutusu 61">
              <a:extLst>
                <a:ext uri="{FF2B5EF4-FFF2-40B4-BE49-F238E27FC236}">
                  <a16:creationId xmlns:a16="http://schemas.microsoft.com/office/drawing/2014/main" id="{34545A5C-CBF8-DCC7-F820-F3505F25AE47}"/>
                </a:ext>
              </a:extLst>
            </p:cNvPr>
            <p:cNvSpPr txBox="1"/>
            <p:nvPr/>
          </p:nvSpPr>
          <p:spPr>
            <a:xfrm>
              <a:off x="188771" y="3854463"/>
              <a:ext cx="1332985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5</a:t>
              </a:r>
            </a:p>
          </p:txBody>
        </p:sp>
        <p:sp>
          <p:nvSpPr>
            <p:cNvPr id="63" name="Metin kutusu 62">
              <a:extLst>
                <a:ext uri="{FF2B5EF4-FFF2-40B4-BE49-F238E27FC236}">
                  <a16:creationId xmlns:a16="http://schemas.microsoft.com/office/drawing/2014/main" id="{CCCB9F6D-548E-A800-85CE-9DBD92A1BFB8}"/>
                </a:ext>
              </a:extLst>
            </p:cNvPr>
            <p:cNvSpPr txBox="1"/>
            <p:nvPr/>
          </p:nvSpPr>
          <p:spPr>
            <a:xfrm>
              <a:off x="189431" y="4626636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6</a:t>
              </a:r>
            </a:p>
          </p:txBody>
        </p:sp>
        <p:sp>
          <p:nvSpPr>
            <p:cNvPr id="64" name="Metin kutusu 63">
              <a:extLst>
                <a:ext uri="{FF2B5EF4-FFF2-40B4-BE49-F238E27FC236}">
                  <a16:creationId xmlns:a16="http://schemas.microsoft.com/office/drawing/2014/main" id="{63D6948C-5BF6-F0EC-ECB6-0611A96DA2C8}"/>
                </a:ext>
              </a:extLst>
            </p:cNvPr>
            <p:cNvSpPr txBox="1"/>
            <p:nvPr/>
          </p:nvSpPr>
          <p:spPr>
            <a:xfrm>
              <a:off x="189431" y="5558848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7</a:t>
              </a:r>
            </a:p>
          </p:txBody>
        </p:sp>
        <p:grpSp>
          <p:nvGrpSpPr>
            <p:cNvPr id="66" name="Grup 65">
              <a:extLst>
                <a:ext uri="{FF2B5EF4-FFF2-40B4-BE49-F238E27FC236}">
                  <a16:creationId xmlns:a16="http://schemas.microsoft.com/office/drawing/2014/main" id="{94B98459-C40E-6EBA-1E3C-61149CB2B78D}"/>
                </a:ext>
              </a:extLst>
            </p:cNvPr>
            <p:cNvGrpSpPr/>
            <p:nvPr/>
          </p:nvGrpSpPr>
          <p:grpSpPr>
            <a:xfrm>
              <a:off x="10281218" y="1253992"/>
              <a:ext cx="1721351" cy="3410339"/>
              <a:chOff x="6645331" y="40658"/>
              <a:chExt cx="2638886" cy="4065165"/>
            </a:xfrm>
          </p:grpSpPr>
          <p:grpSp>
            <p:nvGrpSpPr>
              <p:cNvPr id="67" name="Grup 66">
                <a:extLst>
                  <a:ext uri="{FF2B5EF4-FFF2-40B4-BE49-F238E27FC236}">
                    <a16:creationId xmlns:a16="http://schemas.microsoft.com/office/drawing/2014/main" id="{FA6B1115-F559-0211-56BD-19C41A686225}"/>
                  </a:ext>
                </a:extLst>
              </p:cNvPr>
              <p:cNvGrpSpPr/>
              <p:nvPr/>
            </p:nvGrpSpPr>
            <p:grpSpPr>
              <a:xfrm>
                <a:off x="6645331" y="40658"/>
                <a:ext cx="2055257" cy="4065165"/>
                <a:chOff x="6645331" y="40658"/>
                <a:chExt cx="2055257" cy="4065165"/>
              </a:xfrm>
            </p:grpSpPr>
            <p:pic>
              <p:nvPicPr>
                <p:cNvPr id="71" name="Resim 70">
                  <a:extLst>
                    <a:ext uri="{FF2B5EF4-FFF2-40B4-BE49-F238E27FC236}">
                      <a16:creationId xmlns:a16="http://schemas.microsoft.com/office/drawing/2014/main" id="{FFBB643F-BDAC-37CA-9AFE-639C31BD7BF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2359" t="68465" r="1953" b="8974"/>
                <a:stretch/>
              </p:blipFill>
              <p:spPr>
                <a:xfrm>
                  <a:off x="7290731" y="40658"/>
                  <a:ext cx="1409857" cy="1806682"/>
                </a:xfrm>
                <a:prstGeom prst="rect">
                  <a:avLst/>
                </a:prstGeom>
              </p:spPr>
            </p:pic>
            <p:grpSp>
              <p:nvGrpSpPr>
                <p:cNvPr id="72" name="Grup 71">
                  <a:extLst>
                    <a:ext uri="{FF2B5EF4-FFF2-40B4-BE49-F238E27FC236}">
                      <a16:creationId xmlns:a16="http://schemas.microsoft.com/office/drawing/2014/main" id="{9AFD57A5-33DD-582E-69FC-4FFE6AE9A8CA}"/>
                    </a:ext>
                  </a:extLst>
                </p:cNvPr>
                <p:cNvGrpSpPr/>
                <p:nvPr/>
              </p:nvGrpSpPr>
              <p:grpSpPr>
                <a:xfrm>
                  <a:off x="6645331" y="1846386"/>
                  <a:ext cx="1236823" cy="2259437"/>
                  <a:chOff x="6614911" y="2388265"/>
                  <a:chExt cx="1236823" cy="2259437"/>
                </a:xfrm>
              </p:grpSpPr>
              <p:pic>
                <p:nvPicPr>
                  <p:cNvPr id="73" name="Resim 72">
                    <a:extLst>
                      <a:ext uri="{FF2B5EF4-FFF2-40B4-BE49-F238E27FC236}">
                        <a16:creationId xmlns:a16="http://schemas.microsoft.com/office/drawing/2014/main" id="{DCE4F790-24AA-2B76-62A7-792C9E0C083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89855" b="65524"/>
                  <a:stretch/>
                </p:blipFill>
                <p:spPr>
                  <a:xfrm>
                    <a:off x="6614911" y="2388265"/>
                    <a:ext cx="1236823" cy="2259437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74" name="Metin kutusu 73">
                    <a:extLst>
                      <a:ext uri="{FF2B5EF4-FFF2-40B4-BE49-F238E27FC236}">
                        <a16:creationId xmlns:a16="http://schemas.microsoft.com/office/drawing/2014/main" id="{3F8D23F2-21FA-775F-F998-24A142157EDC}"/>
                      </a:ext>
                    </a:extLst>
                  </p:cNvPr>
                  <p:cNvSpPr txBox="1"/>
                  <p:nvPr/>
                </p:nvSpPr>
                <p:spPr>
                  <a:xfrm>
                    <a:off x="7421622" y="4113188"/>
                    <a:ext cx="287646" cy="369332"/>
                  </a:xfrm>
                  <a:prstGeom prst="rect">
                    <a:avLst/>
                  </a:prstGeom>
                  <a:noFill/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tr-TR" dirty="0"/>
                      <a:t>A</a:t>
                    </a:r>
                  </a:p>
                </p:txBody>
              </p:sp>
            </p:grpSp>
          </p:grpSp>
          <p:grpSp>
            <p:nvGrpSpPr>
              <p:cNvPr id="68" name="Grup 67">
                <a:extLst>
                  <a:ext uri="{FF2B5EF4-FFF2-40B4-BE49-F238E27FC236}">
                    <a16:creationId xmlns:a16="http://schemas.microsoft.com/office/drawing/2014/main" id="{D084289A-70BD-3755-30A8-1B721CA6C997}"/>
                  </a:ext>
                </a:extLst>
              </p:cNvPr>
              <p:cNvGrpSpPr/>
              <p:nvPr/>
            </p:nvGrpSpPr>
            <p:grpSpPr>
              <a:xfrm>
                <a:off x="8047395" y="1841351"/>
                <a:ext cx="1236822" cy="2259437"/>
                <a:chOff x="8213836" y="2383230"/>
                <a:chExt cx="1236822" cy="2259437"/>
              </a:xfrm>
            </p:grpSpPr>
            <p:pic>
              <p:nvPicPr>
                <p:cNvPr id="69" name="Resim 68">
                  <a:extLst>
                    <a:ext uri="{FF2B5EF4-FFF2-40B4-BE49-F238E27FC236}">
                      <a16:creationId xmlns:a16="http://schemas.microsoft.com/office/drawing/2014/main" id="{FD148A2A-8B5A-31E2-0E99-5E3EECD5B1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89855" b="65524"/>
                <a:stretch/>
              </p:blipFill>
              <p:spPr>
                <a:xfrm>
                  <a:off x="8213836" y="2383230"/>
                  <a:ext cx="1236822" cy="225943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70" name="Metin kutusu 69">
                  <a:extLst>
                    <a:ext uri="{FF2B5EF4-FFF2-40B4-BE49-F238E27FC236}">
                      <a16:creationId xmlns:a16="http://schemas.microsoft.com/office/drawing/2014/main" id="{45679889-BE0C-7F0D-0EB4-66B2287D4E5F}"/>
                    </a:ext>
                  </a:extLst>
                </p:cNvPr>
                <p:cNvSpPr txBox="1"/>
                <p:nvPr/>
              </p:nvSpPr>
              <p:spPr>
                <a:xfrm>
                  <a:off x="9042103" y="4113188"/>
                  <a:ext cx="293674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tr-TR" dirty="0"/>
                    <a:t>B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761423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29</Words>
  <Application>Microsoft Office PowerPoint</Application>
  <PresentationFormat>Geniş ekran</PresentationFormat>
  <Paragraphs>12</Paragraphs>
  <Slides>1</Slides>
  <Notes>1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4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eması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Beril Demircan</dc:creator>
  <cp:lastModifiedBy>Beril Demircan</cp:lastModifiedBy>
  <cp:revision>13</cp:revision>
  <dcterms:created xsi:type="dcterms:W3CDTF">2023-05-18T11:13:17Z</dcterms:created>
  <dcterms:modified xsi:type="dcterms:W3CDTF">2023-09-07T06:27:36Z</dcterms:modified>
</cp:coreProperties>
</file>